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994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5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4861" autoAdjust="0"/>
    <p:restoredTop sz="94249" autoAdjust="0"/>
  </p:normalViewPr>
  <p:slideViewPr>
    <p:cSldViewPr snapToGrid="0">
      <p:cViewPr varScale="1">
        <p:scale>
          <a:sx n="75" d="100"/>
          <a:sy n="75" d="100"/>
        </p:scale>
        <p:origin x="387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5383D3-7533-4F92-BB86-048AA300FA8C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0C369A-DCF9-476C-B20C-AB6FEA96DF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4890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41425"/>
            <a:ext cx="2317750" cy="334962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4395D4-C97B-418B-A156-F9226187D5D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12689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235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749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4901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209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069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421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89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332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0320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6217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3662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EDC7E-7637-4AD5-A343-6941F03C3CAB}" type="datetimeFigureOut">
              <a:rPr kumimoji="1" lang="ja-JP" altLang="en-US" smtClean="0"/>
              <a:t>2021/1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DEB8E7-DDFF-465A-AD07-48AF1D01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790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矢印: 下 31">
            <a:extLst>
              <a:ext uri="{FF2B5EF4-FFF2-40B4-BE49-F238E27FC236}">
                <a16:creationId xmlns:a16="http://schemas.microsoft.com/office/drawing/2014/main" id="{8D8035F5-1BD3-4EC8-A404-00E8D5A709B7}"/>
              </a:ext>
            </a:extLst>
          </p:cNvPr>
          <p:cNvSpPr/>
          <p:nvPr/>
        </p:nvSpPr>
        <p:spPr>
          <a:xfrm>
            <a:off x="706028" y="1459153"/>
            <a:ext cx="268498" cy="348633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461ABFE3-C4DC-4AEB-9F42-A03451A21AB8}"/>
              </a:ext>
            </a:extLst>
          </p:cNvPr>
          <p:cNvGrpSpPr/>
          <p:nvPr/>
        </p:nvGrpSpPr>
        <p:grpSpPr>
          <a:xfrm>
            <a:off x="237314" y="496307"/>
            <a:ext cx="2972949" cy="911937"/>
            <a:chOff x="2834673" y="868847"/>
            <a:chExt cx="5290097" cy="1122729"/>
          </a:xfrm>
        </p:grpSpPr>
        <p:sp>
          <p:nvSpPr>
            <p:cNvPr id="5" name="四角形: 角を丸くする 4">
              <a:extLst>
                <a:ext uri="{FF2B5EF4-FFF2-40B4-BE49-F238E27FC236}">
                  <a16:creationId xmlns:a16="http://schemas.microsoft.com/office/drawing/2014/main" id="{B382CFCB-BE3C-427D-A9E9-69D6BCF10554}"/>
                </a:ext>
              </a:extLst>
            </p:cNvPr>
            <p:cNvSpPr/>
            <p:nvPr/>
          </p:nvSpPr>
          <p:spPr>
            <a:xfrm>
              <a:off x="2834673" y="868847"/>
              <a:ext cx="5290097" cy="1120018"/>
            </a:xfrm>
            <a:prstGeom prst="round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ja-JP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l 91,634 residents aged ≥75 years in Tottori Prefecture were enrolled in the Medical Care System as elderly individuals in 2017. </a:t>
              </a:r>
              <a:endParaRPr lang="ja-JP" alt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85ADBE52-FE16-456D-9699-E472A1B08B72}"/>
                </a:ext>
              </a:extLst>
            </p:cNvPr>
            <p:cNvSpPr/>
            <p:nvPr/>
          </p:nvSpPr>
          <p:spPr>
            <a:xfrm>
              <a:off x="2965160" y="871558"/>
              <a:ext cx="4845034" cy="11200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93BD7165-BD0D-4600-82A8-2DA627090FF9}"/>
              </a:ext>
            </a:extLst>
          </p:cNvPr>
          <p:cNvGrpSpPr/>
          <p:nvPr/>
        </p:nvGrpSpPr>
        <p:grpSpPr>
          <a:xfrm>
            <a:off x="237314" y="4964089"/>
            <a:ext cx="3191686" cy="909735"/>
            <a:chOff x="2273872" y="5117594"/>
            <a:chExt cx="6427880" cy="707872"/>
          </a:xfrm>
        </p:grpSpPr>
        <p:sp>
          <p:nvSpPr>
            <p:cNvPr id="35" name="四角形: 角を丸くする 34">
              <a:extLst>
                <a:ext uri="{FF2B5EF4-FFF2-40B4-BE49-F238E27FC236}">
                  <a16:creationId xmlns:a16="http://schemas.microsoft.com/office/drawing/2014/main" id="{61E373D3-6404-4287-B4CD-3EDA583481B1}"/>
                </a:ext>
              </a:extLst>
            </p:cNvPr>
            <p:cNvSpPr/>
            <p:nvPr/>
          </p:nvSpPr>
          <p:spPr>
            <a:xfrm>
              <a:off x="2413054" y="5117594"/>
              <a:ext cx="6288698" cy="707872"/>
            </a:xfrm>
            <a:prstGeom prst="round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ja-JP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365 (96.9%) patients with cancer were accurately identified using this method, which was developed by the local administrative office</a:t>
              </a:r>
              <a:r>
                <a:rPr lang="en-US" altLang="ja-JP" sz="11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en-US" altLang="ja-JP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1086E0E2-68AB-4DD1-8025-4011CFB2E256}"/>
                </a:ext>
              </a:extLst>
            </p:cNvPr>
            <p:cNvSpPr/>
            <p:nvPr/>
          </p:nvSpPr>
          <p:spPr>
            <a:xfrm>
              <a:off x="2273872" y="5182203"/>
              <a:ext cx="6427879" cy="5870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04BC525E-D47F-4BEE-BE28-93849D05D919}"/>
              </a:ext>
            </a:extLst>
          </p:cNvPr>
          <p:cNvGrpSpPr/>
          <p:nvPr/>
        </p:nvGrpSpPr>
        <p:grpSpPr>
          <a:xfrm>
            <a:off x="2139696" y="1703926"/>
            <a:ext cx="2727379" cy="645804"/>
            <a:chOff x="2683047" y="3188876"/>
            <a:chExt cx="5679483" cy="1148096"/>
          </a:xfrm>
        </p:grpSpPr>
        <p:sp>
          <p:nvSpPr>
            <p:cNvPr id="16" name="四角形: 角を丸くする 15">
              <a:extLst>
                <a:ext uri="{FF2B5EF4-FFF2-40B4-BE49-F238E27FC236}">
                  <a16:creationId xmlns:a16="http://schemas.microsoft.com/office/drawing/2014/main" id="{24EFF5BC-3857-41A6-8648-B0D8D1FE9F10}"/>
                </a:ext>
              </a:extLst>
            </p:cNvPr>
            <p:cNvSpPr/>
            <p:nvPr/>
          </p:nvSpPr>
          <p:spPr>
            <a:xfrm>
              <a:off x="2683047" y="3188876"/>
              <a:ext cx="5679483" cy="1120018"/>
            </a:xfrm>
            <a:prstGeom prst="round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ja-JP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ncer Registry Data from Tottori Prefecture in 2017.</a:t>
              </a:r>
              <a:endParaRPr lang="ja-JP" alt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B3D5FCA0-2586-4882-8F7B-12B61924BDA2}"/>
                </a:ext>
              </a:extLst>
            </p:cNvPr>
            <p:cNvSpPr/>
            <p:nvPr/>
          </p:nvSpPr>
          <p:spPr>
            <a:xfrm>
              <a:off x="2692518" y="3216954"/>
              <a:ext cx="5390318" cy="11200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52BBD4B-4CFC-4CCA-93C8-80F70EA5E3AB}"/>
              </a:ext>
            </a:extLst>
          </p:cNvPr>
          <p:cNvSpPr txBox="1"/>
          <p:nvPr/>
        </p:nvSpPr>
        <p:spPr>
          <a:xfrm>
            <a:off x="151136" y="6777805"/>
            <a:ext cx="6069190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 used the same method to combine the National Health Insurance data</a:t>
            </a:r>
            <a:r>
              <a:rPr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ged </a:t>
            </a:r>
            <a:r>
              <a:rPr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＜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years) and Cancer Registry data</a:t>
            </a:r>
            <a:r>
              <a:rPr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矢印: 下 20">
            <a:extLst>
              <a:ext uri="{FF2B5EF4-FFF2-40B4-BE49-F238E27FC236}">
                <a16:creationId xmlns:a16="http://schemas.microsoft.com/office/drawing/2014/main" id="{8EC02E40-3BC9-4F37-8EDC-938754AA397C}"/>
              </a:ext>
            </a:extLst>
          </p:cNvPr>
          <p:cNvSpPr/>
          <p:nvPr/>
        </p:nvSpPr>
        <p:spPr>
          <a:xfrm>
            <a:off x="727027" y="5848729"/>
            <a:ext cx="185457" cy="80350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1349D8-7382-45F3-8C7F-3731C0463C65}"/>
              </a:ext>
            </a:extLst>
          </p:cNvPr>
          <p:cNvSpPr txBox="1"/>
          <p:nvPr/>
        </p:nvSpPr>
        <p:spPr>
          <a:xfrm>
            <a:off x="119276" y="8446847"/>
            <a:ext cx="5471492" cy="2654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25" kern="1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dditional file 1. Description of the method used to examine the accuracy of data matching</a:t>
            </a:r>
            <a:endParaRPr lang="en-IN" sz="1125" kern="1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FE8339B-D1ED-4390-9141-B48BEE981EFC}"/>
              </a:ext>
            </a:extLst>
          </p:cNvPr>
          <p:cNvSpPr txBox="1"/>
          <p:nvPr/>
        </p:nvSpPr>
        <p:spPr>
          <a:xfrm>
            <a:off x="2139696" y="2341237"/>
            <a:ext cx="3010245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40 patients aged ≥ 75 years with cancer were registered in the Cancer Registry Database.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A990264-D90E-45CD-956C-B6010B04B95A}"/>
              </a:ext>
            </a:extLst>
          </p:cNvPr>
          <p:cNvSpPr txBox="1"/>
          <p:nvPr/>
        </p:nvSpPr>
        <p:spPr>
          <a:xfrm>
            <a:off x="974526" y="2914865"/>
            <a:ext cx="4009006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dministrative agency in Tottori Prefecture combined data from two databases using name and birth date.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矢印: 下 18">
            <a:extLst>
              <a:ext uri="{FF2B5EF4-FFF2-40B4-BE49-F238E27FC236}">
                <a16:creationId xmlns:a16="http://schemas.microsoft.com/office/drawing/2014/main" id="{359B1125-9AFC-4AEB-84DF-75A7D8E693EB}"/>
              </a:ext>
            </a:extLst>
          </p:cNvPr>
          <p:cNvSpPr/>
          <p:nvPr/>
        </p:nvSpPr>
        <p:spPr>
          <a:xfrm>
            <a:off x="4724030" y="4177993"/>
            <a:ext cx="185457" cy="80350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2E6339F5-514E-402C-A422-D39838DBACBF}"/>
              </a:ext>
            </a:extLst>
          </p:cNvPr>
          <p:cNvCxnSpPr>
            <a:cxnSpLocks/>
          </p:cNvCxnSpPr>
          <p:nvPr/>
        </p:nvCxnSpPr>
        <p:spPr>
          <a:xfrm>
            <a:off x="912484" y="4179662"/>
            <a:ext cx="3954591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4D652A05-59EC-4BE2-98B7-9307F9BEFC27}"/>
              </a:ext>
            </a:extLst>
          </p:cNvPr>
          <p:cNvGrpSpPr/>
          <p:nvPr/>
        </p:nvGrpSpPr>
        <p:grpSpPr>
          <a:xfrm>
            <a:off x="3554098" y="4970751"/>
            <a:ext cx="3191686" cy="909735"/>
            <a:chOff x="2273872" y="5117594"/>
            <a:chExt cx="6427880" cy="707872"/>
          </a:xfrm>
        </p:grpSpPr>
        <p:sp>
          <p:nvSpPr>
            <p:cNvPr id="23" name="四角形: 角を丸くする 22">
              <a:extLst>
                <a:ext uri="{FF2B5EF4-FFF2-40B4-BE49-F238E27FC236}">
                  <a16:creationId xmlns:a16="http://schemas.microsoft.com/office/drawing/2014/main" id="{E4724F2A-F938-4F3B-81B7-FE6A20EDBCAB}"/>
                </a:ext>
              </a:extLst>
            </p:cNvPr>
            <p:cNvSpPr/>
            <p:nvPr/>
          </p:nvSpPr>
          <p:spPr>
            <a:xfrm>
              <a:off x="2413054" y="5117594"/>
              <a:ext cx="6288698" cy="707872"/>
            </a:xfrm>
            <a:prstGeom prst="round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altLang="ja-JP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 (3.1%) cases in the cancer registry could not be identified.</a:t>
              </a:r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022C401D-D6D3-4682-BD58-4F1C0A89739E}"/>
                </a:ext>
              </a:extLst>
            </p:cNvPr>
            <p:cNvSpPr/>
            <p:nvPr/>
          </p:nvSpPr>
          <p:spPr>
            <a:xfrm>
              <a:off x="2273872" y="5182203"/>
              <a:ext cx="6427879" cy="5870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1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" name="矢印: 下 24">
            <a:extLst>
              <a:ext uri="{FF2B5EF4-FFF2-40B4-BE49-F238E27FC236}">
                <a16:creationId xmlns:a16="http://schemas.microsoft.com/office/drawing/2014/main" id="{B6E78C03-052D-4C78-9A07-6259D1CDB3A2}"/>
              </a:ext>
            </a:extLst>
          </p:cNvPr>
          <p:cNvSpPr/>
          <p:nvPr/>
        </p:nvSpPr>
        <p:spPr>
          <a:xfrm rot="5400000" flipH="1">
            <a:off x="1436614" y="1495442"/>
            <a:ext cx="245542" cy="116517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2439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3</TotalTime>
  <Words>142</Words>
  <Application>Microsoft Office PowerPoint</Application>
  <PresentationFormat>A4 210 x 297 mm</PresentationFormat>
  <Paragraphs>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祐樹 桑原</dc:creator>
  <cp:lastModifiedBy>祐樹 桑原</cp:lastModifiedBy>
  <cp:revision>47</cp:revision>
  <cp:lastPrinted>2021-05-06T08:05:21Z</cp:lastPrinted>
  <dcterms:created xsi:type="dcterms:W3CDTF">2020-01-12T05:52:00Z</dcterms:created>
  <dcterms:modified xsi:type="dcterms:W3CDTF">2021-11-22T04:47:48Z</dcterms:modified>
</cp:coreProperties>
</file>